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7" r:id="rId2"/>
    <p:sldId id="26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66"/>
    <a:srgbClr val="117916"/>
    <a:srgbClr val="FF6600"/>
    <a:srgbClr val="C96009"/>
    <a:srgbClr val="F8A968"/>
    <a:srgbClr val="3AD269"/>
    <a:srgbClr val="F9B47B"/>
    <a:srgbClr val="F9B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06" autoAdjust="0"/>
    <p:restoredTop sz="94660"/>
  </p:normalViewPr>
  <p:slideViewPr>
    <p:cSldViewPr>
      <p:cViewPr varScale="1">
        <p:scale>
          <a:sx n="84" d="100"/>
          <a:sy n="84" d="100"/>
        </p:scale>
        <p:origin x="1819" y="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B75CC3-CC4A-41A0-AB39-D81BB71C6333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83CBF3-8CFB-43E2-AC44-348029D7051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126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25034-C559-4CF9-9F30-7982DEFEF4C0}" type="datetimeFigureOut">
              <a:rPr lang="zh-CN" altLang="en-US" smtClean="0"/>
              <a:pPr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84A6-23F8-4788-9489-8EACEB7685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512" y="908720"/>
            <a:ext cx="7931645" cy="362723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4664717"/>
            <a:ext cx="5393982" cy="818867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0" y="1190"/>
            <a:ext cx="8820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transporters supposed to mediate key</a:t>
            </a:r>
            <a:r>
              <a:rPr lang="en-US" altLang="zh-CN" dirty="0" smtClean="0"/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ation processes. ‘√’ represents the potential candidates and ‘?’ means less possibility.</a:t>
            </a:r>
          </a:p>
        </p:txBody>
      </p:sp>
    </p:spTree>
    <p:extLst>
      <p:ext uri="{BB962C8B-B14F-4D97-AF65-F5344CB8AC3E}">
        <p14:creationId xmlns:p14="http://schemas.microsoft.com/office/powerpoint/2010/main" val="47524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20" y="1196752"/>
            <a:ext cx="8093870" cy="3275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0393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/>
      </a:spPr>
      <a:bodyPr rtlCol="0" anchor="ctr"/>
      <a:lstStyle>
        <a:defPPr algn="ctr">
          <a:defRPr/>
        </a:defPPr>
      </a:lstStyle>
      <a:style>
        <a:lnRef idx="0">
          <a:schemeClr val="accent2"/>
        </a:lnRef>
        <a:fillRef idx="3">
          <a:schemeClr val="accent2"/>
        </a:fillRef>
        <a:effectRef idx="3">
          <a:schemeClr val="accent2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2</TotalTime>
  <Words>25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Times New Roman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MDPI</cp:lastModifiedBy>
  <cp:revision>403</cp:revision>
  <dcterms:created xsi:type="dcterms:W3CDTF">2019-04-08T03:02:22Z</dcterms:created>
  <dcterms:modified xsi:type="dcterms:W3CDTF">2020-09-17T03:47:13Z</dcterms:modified>
</cp:coreProperties>
</file>